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1692" autoAdjust="0"/>
  </p:normalViewPr>
  <p:slideViewPr>
    <p:cSldViewPr snapToGrid="0">
      <p:cViewPr varScale="1">
        <p:scale>
          <a:sx n="119" d="100"/>
          <a:sy n="119" d="100"/>
        </p:scale>
        <p:origin x="96" y="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48038-7D18-4A97-B9D0-3582D2EE5865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A5E4F9-9BCC-47B6-8FE2-C9D4317DD4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7898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Trudzinski et al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pir Res. 2024 Jan 27;25(1):60. 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BA5E4F9-9BCC-47B6-8FE2-C9D4317DD42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88403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56DEE9-FA56-485B-B219-52349DD29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C42B1E9-65E6-4CD2-8388-8705447604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6ECF458-C539-4D25-8DD9-7107B247A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B40D887-2BBC-4AB2-B86C-2654C6E6F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0938F22-DB9C-4279-80BD-42FB576B3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8698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D442A7-C48D-49CC-9B68-4923C589F2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EFD851C-CA47-410F-B335-63D2506722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17579D1-BBEC-4F46-872C-AD0DCB163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CCD80A8-FBDB-428A-B090-FCAFF1A5A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BDE65F5-1953-4D18-ACA1-EA06D556F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0174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8EA9A94-8282-413B-BF7E-FB45324108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0EAF6D8-9F17-443D-B298-98A93F41A9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E492314-6502-4F99-BAD4-09D8F30BA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DD937DB-3C52-4E93-88B3-5CBE1F03D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01A68E-03D1-466D-88D4-9CDED8291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7761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2A22C6-065C-401F-A002-D80663DAC9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9E1AC9-2329-4284-A486-99F0967A07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995BB34-A9BA-47E7-A60C-6FDB93110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5316188-508A-4F90-80BB-E53A818E1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C9FDA90-A9C5-46C1-8F97-BE652C022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7152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8244CE5-C3E5-42B9-ADBE-8D4E42CE7E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5CD5F84-E661-4E13-A440-19B3A033EB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54A63F3-7184-4493-84D9-7F8DCAC7C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89F7EDC-0177-4446-A919-334DBCCA5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475316A-C10E-41FC-9974-4F0085DCD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8400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5C72C7D-981E-4DB5-B3B9-9F6AE2579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429DE58-6FCF-4199-878D-591BBAF101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61E0BDB-96EE-42B1-8EE8-17DD85AD0A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BB55FDC-1DCF-43C4-9610-14AA4E79E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0703741-F0BC-461C-BEFB-36A28E75B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6C77E3-7963-45AA-A66C-CF3ADE910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6370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3987104-B20D-41B4-A400-329D1E86F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F7BF9EC-F558-46EF-A10C-846AABFAAD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0845D38-FDD3-41F9-9CA9-983DF5B086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0E3916D-7C09-4326-A623-2ABE06EA71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0F232FE-F5BB-40C7-9C10-7BF204283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053B000-40C2-45C4-A102-5EEB5ED65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A050B80-F036-4E3A-A858-6DC82981E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4C97970-2FBC-461D-9A07-EDD236270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0181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B57938-5FD5-475C-A426-A431C2B99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C1DE4FAD-AF6B-4ADC-A03A-687BB16F6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DF7692E-2D3A-416C-9B05-4D3D42D19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DF5A18E-4BE1-41BF-B09A-1D2E56FF5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3102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D55955B1-0868-4EF6-A5FD-76B32699B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FFABCFA-282E-4D87-9C6F-5A91A58F7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82C17B2-14E8-4EE3-AEF4-A148B32EF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470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7A172C-3EDF-49B5-83C1-E27C648134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0531ED5-AF78-479B-8F17-743744FCB0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B5B9C79-03A9-4410-B3C6-44CD0458D5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D6188B4-C669-446E-97CD-2ADCC71E2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6580ADF-7AC9-45AC-BF89-C0E86828F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1F8F10E-B214-48B5-B8F8-88AB72670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3591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B2F154-071B-4484-9557-D7002557D8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0A3B8570-4427-49E3-AE91-1C6FF376C9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E0D35CA-24B7-40B3-A245-A8F11D9778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84AC7AB-4975-46F3-BE95-E8B78F6C6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85AF4AC-544A-4D67-B308-E72772569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6DB4851-7687-4CED-B725-F703B09BA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2972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15103F0-A434-47CB-AE61-22427B39B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ADBE7DF-BF03-4362-87AB-7AD066D7E5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EA5513-6E96-4708-8316-0B09554A34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3F8EC-91E4-442F-BAC6-3B60B9F89E26}" type="datetimeFigureOut">
              <a:rPr lang="de-DE" smtClean="0"/>
              <a:t>17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600489-32FD-4E8A-8D04-1F170E52E5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862865C-01A1-45F0-8BAD-F694435771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BBAC6-743C-42FB-AB32-443ABE3245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2948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el 1">
            <a:extLst>
              <a:ext uri="{FF2B5EF4-FFF2-40B4-BE49-F238E27FC236}">
                <a16:creationId xmlns:a16="http://schemas.microsoft.com/office/drawing/2014/main" id="{DC7D8E15-466A-4EF6-96B0-54EEBE7921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828800" y="721315"/>
            <a:ext cx="9144000" cy="2387600"/>
          </a:xfrm>
        </p:spPr>
        <p:txBody>
          <a:bodyPr/>
          <a:lstStyle/>
          <a:p>
            <a:endParaRPr lang="de-DE"/>
          </a:p>
        </p:txBody>
      </p:sp>
      <p:sp>
        <p:nvSpPr>
          <p:cNvPr id="6" name="Untertitel 2">
            <a:extLst>
              <a:ext uri="{FF2B5EF4-FFF2-40B4-BE49-F238E27FC236}">
                <a16:creationId xmlns:a16="http://schemas.microsoft.com/office/drawing/2014/main" id="{B20065D7-3AD3-4FBE-B498-895873F5C1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28800" y="3200990"/>
            <a:ext cx="9144000" cy="1655762"/>
          </a:xfrm>
        </p:spPr>
        <p:txBody>
          <a:bodyPr/>
          <a:lstStyle/>
          <a:p>
            <a:endParaRPr lang="de-DE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B723F18F-DDF6-4C18-AAC4-C301AC0E01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431"/>
          <a:stretch/>
        </p:blipFill>
        <p:spPr>
          <a:xfrm>
            <a:off x="745958" y="456594"/>
            <a:ext cx="10972800" cy="4839660"/>
          </a:xfrm>
          <a:prstGeom prst="rect">
            <a:avLst/>
          </a:prstGeom>
        </p:spPr>
      </p:pic>
      <p:sp>
        <p:nvSpPr>
          <p:cNvPr id="9" name="Rechteck 8">
            <a:extLst>
              <a:ext uri="{FF2B5EF4-FFF2-40B4-BE49-F238E27FC236}">
                <a16:creationId xmlns:a16="http://schemas.microsoft.com/office/drawing/2014/main" id="{337FC359-A2B0-46F4-BDFA-9B14FAC87DDC}"/>
              </a:ext>
            </a:extLst>
          </p:cNvPr>
          <p:cNvSpPr/>
          <p:nvPr/>
        </p:nvSpPr>
        <p:spPr>
          <a:xfrm>
            <a:off x="7354970" y="6372545"/>
            <a:ext cx="48370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Trudzinski et al. </a:t>
            </a:r>
            <a:r>
              <a:rPr lang="en-US" dirty="0"/>
              <a:t>Respir Res. 2024 Jan 27;25(1):60. </a:t>
            </a:r>
            <a:endParaRPr lang="de-DE" dirty="0"/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1182EAEB-735B-479F-A9B6-AA1462C6A31A}"/>
              </a:ext>
            </a:extLst>
          </p:cNvPr>
          <p:cNvSpPr/>
          <p:nvPr/>
        </p:nvSpPr>
        <p:spPr>
          <a:xfrm>
            <a:off x="745958" y="5455989"/>
            <a:ext cx="1070008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view of the time periods of predictors and outcomes. The analysis was based on data from the AOK Baden-Württemberg; patients who received IMV ≥ 96 h and were discharged between 2015 </a:t>
            </a:r>
            <a:r>
              <a:rPr lang="en-US" sz="140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2018 </a:t>
            </a:r>
            <a:r>
              <a:rPr lang="en-US" sz="14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400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4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Health claims data were considered, in each case for the previous year and 30 days after </a:t>
            </a:r>
            <a:r>
              <a:rPr lang="en-US" sz="1400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spitalisation</a:t>
            </a:r>
            <a:r>
              <a:rPr lang="en-US" sz="14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bbreviations: OPS official classification of operational procedures in Germany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0601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Breitbild</PresentationFormat>
  <Paragraphs>4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rudzinski, Franziska</dc:creator>
  <cp:lastModifiedBy>Trudzinski, Franziska</cp:lastModifiedBy>
  <cp:revision>2</cp:revision>
  <dcterms:created xsi:type="dcterms:W3CDTF">2025-03-06T11:28:12Z</dcterms:created>
  <dcterms:modified xsi:type="dcterms:W3CDTF">2025-09-17T07:15:08Z</dcterms:modified>
</cp:coreProperties>
</file>